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857"/>
    <p:restoredTop sz="96327"/>
  </p:normalViewPr>
  <p:slideViewPr>
    <p:cSldViewPr snapToGrid="0" snapToObjects="1">
      <p:cViewPr>
        <p:scale>
          <a:sx n="159" d="100"/>
          <a:sy n="159" d="100"/>
        </p:scale>
        <p:origin x="2296" y="-34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8D436-B2B5-104B-B6B6-84778B45AED1}" type="datetimeFigureOut">
              <a:rPr kumimoji="1" lang="ja-JP" altLang="en-US" smtClean="0"/>
              <a:t>2022/3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D15664-9C65-654F-95A5-DA346A033A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62047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8D436-B2B5-104B-B6B6-84778B45AED1}" type="datetimeFigureOut">
              <a:rPr kumimoji="1" lang="ja-JP" altLang="en-US" smtClean="0"/>
              <a:t>2022/3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D15664-9C65-654F-95A5-DA346A033A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78924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8D436-B2B5-104B-B6B6-84778B45AED1}" type="datetimeFigureOut">
              <a:rPr kumimoji="1" lang="ja-JP" altLang="en-US" smtClean="0"/>
              <a:t>2022/3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D15664-9C65-654F-95A5-DA346A033A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65971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8D436-B2B5-104B-B6B6-84778B45AED1}" type="datetimeFigureOut">
              <a:rPr kumimoji="1" lang="ja-JP" altLang="en-US" smtClean="0"/>
              <a:t>2022/3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D15664-9C65-654F-95A5-DA346A033A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04081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8D436-B2B5-104B-B6B6-84778B45AED1}" type="datetimeFigureOut">
              <a:rPr kumimoji="1" lang="ja-JP" altLang="en-US" smtClean="0"/>
              <a:t>2022/3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D15664-9C65-654F-95A5-DA346A033A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29647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8D436-B2B5-104B-B6B6-84778B45AED1}" type="datetimeFigureOut">
              <a:rPr kumimoji="1" lang="ja-JP" altLang="en-US" smtClean="0"/>
              <a:t>2022/3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D15664-9C65-654F-95A5-DA346A033A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48786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8D436-B2B5-104B-B6B6-84778B45AED1}" type="datetimeFigureOut">
              <a:rPr kumimoji="1" lang="ja-JP" altLang="en-US" smtClean="0"/>
              <a:t>2022/3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D15664-9C65-654F-95A5-DA346A033A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77865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8D436-B2B5-104B-B6B6-84778B45AED1}" type="datetimeFigureOut">
              <a:rPr kumimoji="1" lang="ja-JP" altLang="en-US" smtClean="0"/>
              <a:t>2022/3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D15664-9C65-654F-95A5-DA346A033A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1148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8D436-B2B5-104B-B6B6-84778B45AED1}" type="datetimeFigureOut">
              <a:rPr kumimoji="1" lang="ja-JP" altLang="en-US" smtClean="0"/>
              <a:t>2022/3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D15664-9C65-654F-95A5-DA346A033A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41320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8D436-B2B5-104B-B6B6-84778B45AED1}" type="datetimeFigureOut">
              <a:rPr kumimoji="1" lang="ja-JP" altLang="en-US" smtClean="0"/>
              <a:t>2022/3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D15664-9C65-654F-95A5-DA346A033A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85817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8D436-B2B5-104B-B6B6-84778B45AED1}" type="datetimeFigureOut">
              <a:rPr kumimoji="1" lang="ja-JP" altLang="en-US" smtClean="0"/>
              <a:t>2022/3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D15664-9C65-654F-95A5-DA346A033A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08487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78D436-B2B5-104B-B6B6-84778B45AED1}" type="datetimeFigureOut">
              <a:rPr kumimoji="1" lang="ja-JP" altLang="en-US" smtClean="0"/>
              <a:t>2022/3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D15664-9C65-654F-95A5-DA346A033A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78233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F69A51F9-D186-5047-B642-CE450CCD761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3617" y="2251244"/>
            <a:ext cx="2233943" cy="1755241"/>
          </a:xfrm>
          <a:prstGeom prst="rect">
            <a:avLst/>
          </a:prstGeom>
        </p:spPr>
      </p:pic>
      <p:sp>
        <p:nvSpPr>
          <p:cNvPr id="5" name="二等辺三角形 28">
            <a:extLst>
              <a:ext uri="{FF2B5EF4-FFF2-40B4-BE49-F238E27FC236}">
                <a16:creationId xmlns:a16="http://schemas.microsoft.com/office/drawing/2014/main" id="{D741EEDC-1CB6-4543-B2D5-3FFDBA43B65F}"/>
              </a:ext>
            </a:extLst>
          </p:cNvPr>
          <p:cNvSpPr/>
          <p:nvPr/>
        </p:nvSpPr>
        <p:spPr>
          <a:xfrm rot="19037499" flipH="1">
            <a:off x="2346861" y="3413456"/>
            <a:ext cx="97161" cy="140696"/>
          </a:xfrm>
          <a:prstGeom prst="triangl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" name="二等辺三角形 29">
            <a:extLst>
              <a:ext uri="{FF2B5EF4-FFF2-40B4-BE49-F238E27FC236}">
                <a16:creationId xmlns:a16="http://schemas.microsoft.com/office/drawing/2014/main" id="{A9386568-AA56-8941-87AA-BFB30C993D83}"/>
              </a:ext>
            </a:extLst>
          </p:cNvPr>
          <p:cNvSpPr/>
          <p:nvPr/>
        </p:nvSpPr>
        <p:spPr>
          <a:xfrm rot="19037499" flipH="1">
            <a:off x="2961540" y="3116128"/>
            <a:ext cx="97161" cy="140696"/>
          </a:xfrm>
          <a:prstGeom prst="triangl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8BD152E0-1BEE-4E40-B413-4B40EA9F455A}"/>
              </a:ext>
            </a:extLst>
          </p:cNvPr>
          <p:cNvCxnSpPr>
            <a:cxnSpLocks/>
          </p:cNvCxnSpPr>
          <p:nvPr/>
        </p:nvCxnSpPr>
        <p:spPr>
          <a:xfrm>
            <a:off x="2965426" y="3914355"/>
            <a:ext cx="23325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" name="図 7">
            <a:extLst>
              <a:ext uri="{FF2B5EF4-FFF2-40B4-BE49-F238E27FC236}">
                <a16:creationId xmlns:a16="http://schemas.microsoft.com/office/drawing/2014/main" id="{B32E8A36-4CA3-D84A-BAC6-3F67C063507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00" y="2235736"/>
            <a:ext cx="2233943" cy="1755241"/>
          </a:xfrm>
          <a:prstGeom prst="rect">
            <a:avLst/>
          </a:prstGeom>
        </p:spPr>
      </p:pic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C859DA4E-AE36-AB4B-9A70-591DC992D627}"/>
              </a:ext>
            </a:extLst>
          </p:cNvPr>
          <p:cNvCxnSpPr>
            <a:cxnSpLocks/>
          </p:cNvCxnSpPr>
          <p:nvPr/>
        </p:nvCxnSpPr>
        <p:spPr>
          <a:xfrm>
            <a:off x="5309526" y="3886737"/>
            <a:ext cx="23325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" name="図 10">
            <a:extLst>
              <a:ext uri="{FF2B5EF4-FFF2-40B4-BE49-F238E27FC236}">
                <a16:creationId xmlns:a16="http://schemas.microsoft.com/office/drawing/2014/main" id="{6BF1E6B8-E4AC-BD43-8196-17ACD756BCE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3617" y="4154329"/>
            <a:ext cx="2233943" cy="1755241"/>
          </a:xfrm>
          <a:prstGeom prst="rect">
            <a:avLst/>
          </a:prstGeom>
        </p:spPr>
      </p:pic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1D210860-D9AD-324A-A17C-1EB9B007221A}"/>
              </a:ext>
            </a:extLst>
          </p:cNvPr>
          <p:cNvCxnSpPr>
            <a:cxnSpLocks/>
          </p:cNvCxnSpPr>
          <p:nvPr/>
        </p:nvCxnSpPr>
        <p:spPr>
          <a:xfrm>
            <a:off x="2968203" y="5793242"/>
            <a:ext cx="233256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49BCBCB7-7433-E943-8DA0-4A27346ABFD4}"/>
              </a:ext>
            </a:extLst>
          </p:cNvPr>
          <p:cNvSpPr txBox="1"/>
          <p:nvPr/>
        </p:nvSpPr>
        <p:spPr>
          <a:xfrm>
            <a:off x="4556955" y="5024609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ja-JP" altLang="en-US"/>
          </a:p>
        </p:txBody>
      </p:sp>
      <p:pic>
        <p:nvPicPr>
          <p:cNvPr id="14" name="図 13">
            <a:extLst>
              <a:ext uri="{FF2B5EF4-FFF2-40B4-BE49-F238E27FC236}">
                <a16:creationId xmlns:a16="http://schemas.microsoft.com/office/drawing/2014/main" id="{E0A586B2-8D16-ED4A-BB96-4CCF4F3D91F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41650" y="4154491"/>
            <a:ext cx="2230610" cy="1767329"/>
          </a:xfrm>
          <a:prstGeom prst="rect">
            <a:avLst/>
          </a:prstGeom>
        </p:spPr>
      </p:pic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B27B6241-8266-A640-94CB-0AD1678B6F95}"/>
              </a:ext>
            </a:extLst>
          </p:cNvPr>
          <p:cNvCxnSpPr/>
          <p:nvPr/>
        </p:nvCxnSpPr>
        <p:spPr>
          <a:xfrm>
            <a:off x="5441878" y="5793404"/>
            <a:ext cx="13286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770D9580-08BC-8049-989D-E595B42C4F01}"/>
              </a:ext>
            </a:extLst>
          </p:cNvPr>
          <p:cNvSpPr txBox="1"/>
          <p:nvPr/>
        </p:nvSpPr>
        <p:spPr>
          <a:xfrm>
            <a:off x="133815" y="1196898"/>
            <a:ext cx="22878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ea typeface="MS Gothic" panose="020B0609070205080204" pitchFamily="49" charset="-128"/>
                <a:cs typeface="Times New Roman" panose="02020603050405020304" pitchFamily="18" charset="0"/>
              </a:rPr>
              <a:t>Supplemental Figure 1</a:t>
            </a:r>
            <a:endParaRPr kumimoji="1" lang="ja-JP" altLang="en-US">
              <a:latin typeface="Times New Roman" panose="02020603050405020304" pitchFamily="18" charset="0"/>
              <a:ea typeface="MS Gothic" panose="020B0609070205080204" pitchFamily="49" charset="-128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1E1AC583-4BDC-714D-8F16-B59A5F6A86E0}"/>
              </a:ext>
            </a:extLst>
          </p:cNvPr>
          <p:cNvSpPr txBox="1"/>
          <p:nvPr/>
        </p:nvSpPr>
        <p:spPr>
          <a:xfrm>
            <a:off x="1103617" y="223573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</a:t>
            </a:r>
            <a:endParaRPr kumimoji="1" lang="ja-JP" altLang="en-US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5CA07E38-C4F2-D149-9728-5F8C0DBAA591}"/>
              </a:ext>
            </a:extLst>
          </p:cNvPr>
          <p:cNvSpPr txBox="1"/>
          <p:nvPr/>
        </p:nvSpPr>
        <p:spPr>
          <a:xfrm>
            <a:off x="3441650" y="225124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B</a:t>
            </a:r>
            <a:endParaRPr kumimoji="1" lang="ja-JP" altLang="en-US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6F96CD14-AB92-6B41-BDF9-83C4F286E2A5}"/>
              </a:ext>
            </a:extLst>
          </p:cNvPr>
          <p:cNvSpPr txBox="1"/>
          <p:nvPr/>
        </p:nvSpPr>
        <p:spPr>
          <a:xfrm>
            <a:off x="1103617" y="4154329"/>
            <a:ext cx="360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solidFill>
                  <a:schemeClr val="bg1"/>
                </a:solidFill>
              </a:rPr>
              <a:t> C</a:t>
            </a:r>
            <a:endParaRPr kumimoji="1" lang="ja-JP" altLang="en-US">
              <a:solidFill>
                <a:schemeClr val="bg1"/>
              </a:solidFill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008A0706-43E8-034E-A88D-024D006C11AA}"/>
              </a:ext>
            </a:extLst>
          </p:cNvPr>
          <p:cNvSpPr txBox="1"/>
          <p:nvPr/>
        </p:nvSpPr>
        <p:spPr>
          <a:xfrm>
            <a:off x="3386615" y="4154329"/>
            <a:ext cx="3802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 D</a:t>
            </a:r>
            <a:endParaRPr kumimoji="1" lang="ja-JP" altLang="en-US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DBBF9A53-4230-C945-8532-5AB928AF1B66}"/>
              </a:ext>
            </a:extLst>
          </p:cNvPr>
          <p:cNvSpPr txBox="1"/>
          <p:nvPr/>
        </p:nvSpPr>
        <p:spPr>
          <a:xfrm>
            <a:off x="833031" y="6218338"/>
            <a:ext cx="5628464" cy="12772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situ 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ybridization of </a:t>
            </a:r>
            <a:r>
              <a:rPr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l2a1</a:t>
            </a:r>
            <a:r>
              <a:rPr lang="ja-JP" altLang="ja-JP" sz="110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RNA.  A: Tooth socket after day 7 of tooth extraction. </a:t>
            </a:r>
          </a:p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me cells show 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sitive signals of </a:t>
            </a:r>
            <a:r>
              <a:rPr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l2a1</a:t>
            </a:r>
            <a:r>
              <a:rPr lang="ja-JP" altLang="ja-JP" sz="110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RNA in cytoplasm (blue arrow heads) by </a:t>
            </a:r>
          </a:p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ybridization with </a:t>
            </a:r>
            <a:r>
              <a:rPr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l2a1 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sense probe. B: Tooth socket after day 7 tooth extraction. </a:t>
            </a:r>
          </a:p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 signals is observed 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y 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ybridization with </a:t>
            </a:r>
            <a:r>
              <a:rPr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l2a1 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nse probe. C: Tooth socket after day 7 </a:t>
            </a:r>
          </a:p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tooth extraction. Hybridized by 28S antisense probe. D: Cartilage callus of the semi-stabilized</a:t>
            </a:r>
          </a:p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mur fracture after day 7. Chondrocytes show 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sitive signals of  </a:t>
            </a:r>
            <a:r>
              <a:rPr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l2a1</a:t>
            </a:r>
            <a:r>
              <a:rPr lang="ja-JP" altLang="ja-JP" sz="110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RNA. Scale bars </a:t>
            </a:r>
          </a:p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 10 ㎛. </a:t>
            </a:r>
            <a:endParaRPr kumimoji="1" lang="ja-JP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854466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</TotalTime>
  <Words>114</Words>
  <Application>Microsoft Macintosh PowerPoint</Application>
  <PresentationFormat>ワイド画面</PresentationFormat>
  <Paragraphs>1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朗 山口</dc:creator>
  <cp:lastModifiedBy>朗 山口</cp:lastModifiedBy>
  <cp:revision>3</cp:revision>
  <dcterms:created xsi:type="dcterms:W3CDTF">2022-03-09T04:49:44Z</dcterms:created>
  <dcterms:modified xsi:type="dcterms:W3CDTF">2022-03-09T05:27:59Z</dcterms:modified>
</cp:coreProperties>
</file>